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62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8" r:id="rId2"/>
  </p:sldIdLst>
  <p:sldSz cx="6858000" cy="9144000" type="letter"/>
  <p:notesSz cx="6797675" cy="9931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3">
          <p15:clr>
            <a:srgbClr val="A4A3A4"/>
          </p15:clr>
        </p15:guide>
        <p15:guide id="2" pos="21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8E0A5"/>
    <a:srgbClr val="F8A44A"/>
    <a:srgbClr val="4AE260"/>
    <a:srgbClr val="4ABBEA"/>
    <a:srgbClr val="9B9FFC"/>
    <a:srgbClr val="FAEF36"/>
    <a:srgbClr val="F9C63B"/>
    <a:srgbClr val="83F983"/>
    <a:srgbClr val="6FF86F"/>
    <a:srgbClr val="8CE9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87" d="100"/>
          <a:sy n="87" d="100"/>
        </p:scale>
        <p:origin x="3030" y="84"/>
      </p:cViewPr>
      <p:guideLst>
        <p:guide orient="horz" pos="2903"/>
        <p:guide pos="2167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2022/4/28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50443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pPr/>
              <a:t>‹#›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419208820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29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9768" y="4779486"/>
            <a:ext cx="5438140" cy="3910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50443" y="9433107"/>
            <a:ext cx="2945659" cy="49829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4993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1241425"/>
            <a:ext cx="2511425" cy="3351213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376809" y="3451382"/>
            <a:ext cx="6104383" cy="1199008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405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376809" y="4755348"/>
            <a:ext cx="6104383" cy="126810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18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376837" y="1270135"/>
            <a:ext cx="6104383" cy="6720662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376809" y="3451382"/>
            <a:ext cx="6104383" cy="1199008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405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376809" y="1728171"/>
            <a:ext cx="6104383" cy="6722468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37" y="5078807"/>
            <a:ext cx="6104383" cy="833209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27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"/>
            </p:custDataLst>
          </p:nvPr>
        </p:nvSpPr>
        <p:spPr>
          <a:xfrm>
            <a:off x="376834" y="6016159"/>
            <a:ext cx="6104383" cy="143745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2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509368" y="1728170"/>
            <a:ext cx="2971824" cy="6720662"/>
          </a:xfrm>
        </p:spPr>
        <p:txBody>
          <a:bodyPr>
            <a:noAutofit/>
          </a:bodyPr>
          <a:lstStyle>
            <a:lvl1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2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376809" y="576057"/>
            <a:ext cx="6104383" cy="864085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376836" y="1728171"/>
            <a:ext cx="2971824" cy="508054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15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376833" y="2385626"/>
            <a:ext cx="2971800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3507609" y="1728171"/>
            <a:ext cx="2971824" cy="508054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15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3507609" y="2385626"/>
            <a:ext cx="2971824" cy="6070243"/>
          </a:xfrm>
        </p:spPr>
        <p:txBody>
          <a:bodyPr vert="horz" lIns="101600" tIns="0" rIns="82550" bIns="0" rtlCol="0">
            <a:no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1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376836" y="1728170"/>
            <a:ext cx="2971824" cy="6720662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514350" marR="0" lvl="1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857250" marR="0" lvl="2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200150" marR="0" lvl="3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1543050" marR="0" lvl="4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3509395" y="1728170"/>
            <a:ext cx="2971824" cy="6720662"/>
          </a:xfrm>
        </p:spPr>
        <p:txBody>
          <a:bodyPr vert="horz" lIns="101600" tIns="0" rIns="82550" bIns="0" rtlCol="0">
            <a:normAutofit/>
          </a:bodyPr>
          <a:lstStyle>
            <a:lvl1pPr marL="171450" marR="0" lvl="0" indent="-17145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2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pPr/>
              <a:t>2022/4/28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1"/>
            </p:custDataLst>
          </p:nvPr>
        </p:nvSpPr>
        <p:spPr>
          <a:xfrm>
            <a:off x="5946264" y="1270135"/>
            <a:ext cx="534929" cy="718591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1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376833" y="1270125"/>
            <a:ext cx="5528307" cy="718591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376809" y="576057"/>
            <a:ext cx="6104383" cy="864085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376809" y="1728170"/>
            <a:ext cx="6104383" cy="6720662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494855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pPr/>
              <a:t>2022/4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2315250" y="8467279"/>
            <a:ext cx="222750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4843463" y="8467279"/>
            <a:ext cx="1518750" cy="4224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pPr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15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1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207135" algn="l"/>
        </a:tabLst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2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2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矩形 66"/>
          <p:cNvSpPr/>
          <p:nvPr/>
        </p:nvSpPr>
        <p:spPr>
          <a:xfrm>
            <a:off x="601971" y="5743612"/>
            <a:ext cx="528680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Additional file 7</a:t>
            </a:r>
            <a:r>
              <a:rPr lang="en-US" altLang="zh-CN" sz="1200" b="1" dirty="0" smtClean="0">
                <a:latin typeface="Times New Roman" pitchFamily="18" charset="0"/>
                <a:cs typeface="Times New Roman" pitchFamily="18" charset="0"/>
              </a:rPr>
              <a:t>: The 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hypocotyl phenotypes of </a:t>
            </a:r>
            <a:r>
              <a:rPr lang="en-US" altLang="zh-CN" sz="1200" b="1" i="1" dirty="0">
                <a:latin typeface="Times New Roman" pitchFamily="18" charset="0"/>
                <a:cs typeface="Times New Roman" pitchFamily="18" charset="0"/>
              </a:rPr>
              <a:t>VrCCA1L26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transgenic </a:t>
            </a:r>
            <a:r>
              <a:rPr lang="en-US" altLang="zh-CN" sz="1200" b="1" i="1" dirty="0">
                <a:latin typeface="Times New Roman" pitchFamily="18" charset="0"/>
                <a:cs typeface="Times New Roman" pitchFamily="18" charset="0"/>
              </a:rPr>
              <a:t>Arabidopsis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 plants.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The plants were grown under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onstant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darkness conditions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with 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21 °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 for </a:t>
            </a:r>
            <a:r>
              <a:rPr lang="en-US" altLang="zh-CN" sz="1200" dirty="0">
                <a:latin typeface="Times New Roman" pitchFamily="18" charset="0"/>
                <a:cs typeface="Times New Roman" pitchFamily="18" charset="0"/>
              </a:rPr>
              <a:t>10 days. Bar = 4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cm. Col indicates wild-type plants, </a:t>
            </a:r>
            <a:r>
              <a:rPr lang="en-US" altLang="zh-CN" sz="1200" i="1" dirty="0" smtClean="0">
                <a:latin typeface="Times New Roman" pitchFamily="18" charset="0"/>
                <a:cs typeface="Times New Roman" pitchFamily="18" charset="0"/>
              </a:rPr>
              <a:t>VrCCA1L26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200" dirty="0" smtClean="0">
                <a:latin typeface="Times New Roman" pitchFamily="18" charset="0"/>
                <a:cs typeface="Times New Roman" pitchFamily="18" charset="0"/>
              </a:rPr>
              <a:t>indicates two transgenic lines.</a:t>
            </a:r>
            <a:endParaRPr lang="zh-CN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8" name="图片 67" descr="C:\Users\Administrator\Desktop\图片2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18"/>
          <a:stretch>
            <a:fillRect/>
          </a:stretch>
        </p:blipFill>
        <p:spPr>
          <a:xfrm>
            <a:off x="782016" y="3218314"/>
            <a:ext cx="4926714" cy="2258116"/>
          </a:xfrm>
          <a:prstGeom prst="rect">
            <a:avLst/>
          </a:prstGeom>
          <a:noFill/>
          <a:ln>
            <a:noFill/>
          </a:ln>
        </p:spPr>
      </p:pic>
    </p:spTree>
    <p:custDataLst>
      <p:tags r:id="rId1"/>
    </p:custData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2、3、6、8、10、11、12、15"/>
  <p:tag name="KSO_WM_SLIDE_ID" val="custom20187308_1"/>
  <p:tag name="KSO_WM_TEMPLATE_SUBCATEGORY" val="0"/>
  <p:tag name="KSO_WM_SLIDE_TYPE" val="title"/>
  <p:tag name="KSO_WM_SLIDE_SUBTYPE" val="pureTxt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1</TotalTime>
  <Words>46</Words>
  <Application>Microsoft Office PowerPoint</Application>
  <PresentationFormat>信纸(8.5x11 英寸)</PresentationFormat>
  <Paragraphs>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微软雅黑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ishuai</cp:lastModifiedBy>
  <cp:revision>196</cp:revision>
  <cp:lastPrinted>2020-08-03T09:43:32Z</cp:lastPrinted>
  <dcterms:created xsi:type="dcterms:W3CDTF">2020-02-10T12:38:00Z</dcterms:created>
  <dcterms:modified xsi:type="dcterms:W3CDTF">2022-04-28T09:55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597</vt:lpwstr>
  </property>
</Properties>
</file>